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4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107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F281D-C71B-1D04-5FA0-5FD619D25B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5C7349-01D7-8CAF-318B-C2ED6B99A5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en-US" altLang="ja-JP"/>
              <a:t>Click to edit Master subtitle style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E2756A-10A2-0C1F-9656-E55893DCC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570E76-FDE6-5B43-CCC5-644882DAC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3A30E-24D7-0B19-03AD-DA2D67D0A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338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4F7062-3248-AF2A-2B47-F26BB9C753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806F5C-FA0F-3515-A756-691254C463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B360F2-774A-3BDA-5181-D360407D7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2D014E-BE0C-7182-139F-3A0F6B314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54F476-CF37-C194-ABAF-DBFF5F3FD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8097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A08CD0-D99B-50DC-5B80-A414D004E7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10F638-B79F-7D6D-96EA-B04BD1242A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31F121-3FA0-C2A5-8EF6-342F6B7EB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A3C608-E5E0-A6AE-D73F-27F6B76F0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BE0076-30D7-DCA1-DCBE-93DD2D856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468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AB7D50-0D63-9675-9A51-0FBCF4EEF2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082637-D634-286A-A1C7-A46F53A863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C74274-0A2E-6E75-C428-E7B050877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77A7E9-F0F9-CE2E-A208-6B22CD46C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7EE52D-F391-F51E-E614-969F050A35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472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1C00EF-EE0A-AA66-63AB-76EA582C89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15C891-CFA0-9A4A-F7CD-B563C36EF8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8CC94A-B67E-1386-97D1-47F9487F8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D1BE55-E127-F26B-2C80-F43CC09104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F19160-3774-3F4E-E6CC-2CAFB9C64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001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717AAB-2BB5-B311-E45D-10489213D4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CDF9AB-E0A5-EB1F-B92C-2025FD4341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D89565-2A52-B120-5C36-8D5805351E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A44435-1FEC-3A7F-B0FB-AD6195D80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F857E5-BFF7-4753-AC94-DF6377F3CE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F343B0-E8F0-7EDC-DA03-682097487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7047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656E6F-AB1C-65AC-7868-12E3C4B40C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EDFC87-0A30-7FD2-27C6-DEFBB04611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9EFACE-F6D2-BD32-3D01-D2270BD6C8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3E13E48-5408-12D0-EECB-0561C5362D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574E431-7DAF-7351-799A-69BE422CF9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4F8C24-9CC1-583B-C76C-6339C65F9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2D8B842-3EC2-DF99-9652-A1FDF7C62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7F68C2-7199-6135-AECF-AEC1DF8FB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8361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02203D-A0C4-2399-87AA-1B1029E82E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8CC091-7C27-9B0C-767A-ACB8D59DED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450532-089F-B5EC-0415-89BC3085B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DFE560-5757-B70B-CF35-312919114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839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588349-9D60-BD30-2C0C-30B0D321B5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7CB93C7-6D60-311B-57FF-CC7D4EF79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C8C407-4A4D-5A76-05A7-1A03DE240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437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4C2DDC-83C0-34E5-B1F9-BEC48623E6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1594C2-EFCD-E177-D940-5A8272B836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C00539-7F99-9127-6249-6230972CBD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013CB5-7727-8920-468D-4F0366362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9575A8-D5BB-FE24-A004-024072A3FE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FB72DD-A2AC-9092-DB14-7B9D52EC9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851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231870-9E79-E070-8F74-6E54FD5C51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A86CB7B-CCD1-911A-16AE-2135D777E1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A9A963-52EF-4EA5-E291-CCF8566E90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5DDBEE-ABD7-8C64-8F97-7528EEE0BE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A3244A-5E2F-3AA7-A763-C7014FB9D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52D5CF-5A79-30D5-3850-9CB9E59E5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3666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C9C1988-D9BE-C9D7-EE39-048D19F3A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143509-D0DA-E374-3ACC-54EAC9648F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CD744A-3099-FAD0-F1BD-BCD364B197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B0233D-F15B-49DB-8898-F9F80DA114FF}" type="datetimeFigureOut">
              <a:rPr kumimoji="1" lang="ja-JP" altLang="en-US" smtClean="0"/>
              <a:t>2025/9/3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4C2C60-074B-3518-3CE5-3D66EB170F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7CA72D-5BFD-C13C-FD3D-7FFB401151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CDC668-9F9C-4B40-9A9B-C85F8BC792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157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3A2725-F4A7-5BED-ECAE-181F91A8CF5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35AC54F-1C91-5938-ECA1-7B67235CFFD2}"/>
              </a:ext>
            </a:extLst>
          </p:cNvPr>
          <p:cNvSpPr txBox="1"/>
          <p:nvPr/>
        </p:nvSpPr>
        <p:spPr>
          <a:xfrm>
            <a:off x="272143" y="103907"/>
            <a:ext cx="25170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8139E965-A548-F201-A4CE-F12B1ACF8F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849" y="1230085"/>
            <a:ext cx="10628302" cy="39406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85973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4BE0D2E-A1B0-C3A3-9D76-2C23F9DAE15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6AC2ABC-BF70-DE87-37A5-751E5DF434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4629132"/>
              </p:ext>
            </p:extLst>
          </p:nvPr>
        </p:nvGraphicFramePr>
        <p:xfrm>
          <a:off x="2241310" y="1359002"/>
          <a:ext cx="7709379" cy="413999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60360">
                  <a:extLst>
                    <a:ext uri="{9D8B030D-6E8A-4147-A177-3AD203B41FA5}">
                      <a16:colId xmlns:a16="http://schemas.microsoft.com/office/drawing/2014/main" val="3337619247"/>
                    </a:ext>
                  </a:extLst>
                </a:gridCol>
                <a:gridCol w="3015356">
                  <a:extLst>
                    <a:ext uri="{9D8B030D-6E8A-4147-A177-3AD203B41FA5}">
                      <a16:colId xmlns:a16="http://schemas.microsoft.com/office/drawing/2014/main" val="2909433216"/>
                    </a:ext>
                  </a:extLst>
                </a:gridCol>
                <a:gridCol w="2933663">
                  <a:extLst>
                    <a:ext uri="{9D8B030D-6E8A-4147-A177-3AD203B41FA5}">
                      <a16:colId xmlns:a16="http://schemas.microsoft.com/office/drawing/2014/main" val="298530489"/>
                    </a:ext>
                  </a:extLst>
                </a:gridCol>
              </a:tblGrid>
              <a:tr h="676476">
                <a:tc>
                  <a:txBody>
                    <a:bodyPr/>
                    <a:lstStyle/>
                    <a:p>
                      <a:pPr algn="l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Parameter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Pre-procedural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Post-procedural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7469221"/>
                  </a:ext>
                </a:extLst>
              </a:tr>
              <a:tr h="432940">
                <a:tc>
                  <a:txBody>
                    <a:bodyPr/>
                    <a:lstStyle/>
                    <a:p>
                      <a:pPr algn="l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LVEDV (mL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148.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153.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4471617"/>
                  </a:ext>
                </a:extLst>
              </a:tr>
              <a:tr h="432940">
                <a:tc>
                  <a:txBody>
                    <a:bodyPr/>
                    <a:lstStyle/>
                    <a:p>
                      <a:pPr algn="l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LVESV (mL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76.8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76.5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0154819"/>
                  </a:ext>
                </a:extLst>
              </a:tr>
              <a:tr h="432940">
                <a:tc>
                  <a:txBody>
                    <a:bodyPr/>
                    <a:lstStyle/>
                    <a:p>
                      <a:pPr algn="l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LVEF (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48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50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2571058"/>
                  </a:ext>
                </a:extLst>
              </a:tr>
              <a:tr h="432940">
                <a:tc>
                  <a:txBody>
                    <a:bodyPr/>
                    <a:lstStyle/>
                    <a:p>
                      <a:pPr algn="l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RVEDV (mL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98.5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83.9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4175031"/>
                  </a:ext>
                </a:extLst>
              </a:tr>
              <a:tr h="432940">
                <a:tc>
                  <a:txBody>
                    <a:bodyPr/>
                    <a:lstStyle/>
                    <a:p>
                      <a:pPr algn="l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RVESV (mL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48.7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45.0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9646716"/>
                  </a:ext>
                </a:extLst>
              </a:tr>
              <a:tr h="432940">
                <a:tc>
                  <a:txBody>
                    <a:bodyPr/>
                    <a:lstStyle/>
                    <a:p>
                      <a:pPr algn="l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RVEF (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51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46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1553907"/>
                  </a:ext>
                </a:extLst>
              </a:tr>
              <a:tr h="432940">
                <a:tc>
                  <a:txBody>
                    <a:bodyPr/>
                    <a:lstStyle/>
                    <a:p>
                      <a:pPr algn="l"/>
                      <a:r>
                        <a:rPr lang="en-US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Qp</a:t>
                      </a:r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 (L/min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5.7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5.2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847597"/>
                  </a:ext>
                </a:extLst>
              </a:tr>
              <a:tr h="432940">
                <a:tc>
                  <a:txBody>
                    <a:bodyPr/>
                    <a:lstStyle/>
                    <a:p>
                      <a:pPr algn="l"/>
                      <a:r>
                        <a:rPr lang="en-US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Qs (L/min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3.8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rPr>
                        <a:t>4.5</a:t>
                      </a:r>
                      <a:endParaRPr lang="en-US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65623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3279FDD-E863-FBC0-8C87-D7FAB6738F2A}"/>
              </a:ext>
            </a:extLst>
          </p:cNvPr>
          <p:cNvSpPr txBox="1"/>
          <p:nvPr/>
        </p:nvSpPr>
        <p:spPr>
          <a:xfrm>
            <a:off x="272143" y="103907"/>
            <a:ext cx="2409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62540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7</Words>
  <Application>Microsoft Office PowerPoint</Application>
  <PresentationFormat>ワイド画面</PresentationFormat>
  <Paragraphs>29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Theme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隆介 関井</dc:creator>
  <cp:lastModifiedBy>隆介 関井</cp:lastModifiedBy>
  <cp:revision>5</cp:revision>
  <dcterms:created xsi:type="dcterms:W3CDTF">2025-05-20T07:20:23Z</dcterms:created>
  <dcterms:modified xsi:type="dcterms:W3CDTF">2025-09-03T10:32:28Z</dcterms:modified>
</cp:coreProperties>
</file>